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8" r:id="rId3"/>
    <p:sldId id="257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06" autoAdjust="0"/>
    <p:restoredTop sz="94660"/>
  </p:normalViewPr>
  <p:slideViewPr>
    <p:cSldViewPr snapToGrid="0">
      <p:cViewPr varScale="1">
        <p:scale>
          <a:sx n="88" d="100"/>
          <a:sy n="88" d="100"/>
        </p:scale>
        <p:origin x="84" y="4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044C8-8525-4ABB-91BA-2E69F1B2019C}" type="datetimeFigureOut">
              <a:rPr lang="de-DE" smtClean="0"/>
              <a:t>05.08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1C1D0-9BF1-4403-B9BA-F6C91E7F2B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130552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044C8-8525-4ABB-91BA-2E69F1B2019C}" type="datetimeFigureOut">
              <a:rPr lang="de-DE" smtClean="0"/>
              <a:t>05.08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1C1D0-9BF1-4403-B9BA-F6C91E7F2B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151607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044C8-8525-4ABB-91BA-2E69F1B2019C}" type="datetimeFigureOut">
              <a:rPr lang="de-DE" smtClean="0"/>
              <a:t>05.08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1C1D0-9BF1-4403-B9BA-F6C91E7F2B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181482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044C8-8525-4ABB-91BA-2E69F1B2019C}" type="datetimeFigureOut">
              <a:rPr lang="de-DE" smtClean="0"/>
              <a:t>05.08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1C1D0-9BF1-4403-B9BA-F6C91E7F2B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818881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044C8-8525-4ABB-91BA-2E69F1B2019C}" type="datetimeFigureOut">
              <a:rPr lang="de-DE" smtClean="0"/>
              <a:t>05.08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1C1D0-9BF1-4403-B9BA-F6C91E7F2B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8063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044C8-8525-4ABB-91BA-2E69F1B2019C}" type="datetimeFigureOut">
              <a:rPr lang="de-DE" smtClean="0"/>
              <a:t>05.08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1C1D0-9BF1-4403-B9BA-F6C91E7F2B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356734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044C8-8525-4ABB-91BA-2E69F1B2019C}" type="datetimeFigureOut">
              <a:rPr lang="de-DE" smtClean="0"/>
              <a:t>05.08.2020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1C1D0-9BF1-4403-B9BA-F6C91E7F2B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592448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044C8-8525-4ABB-91BA-2E69F1B2019C}" type="datetimeFigureOut">
              <a:rPr lang="de-DE" smtClean="0"/>
              <a:t>05.08.2020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1C1D0-9BF1-4403-B9BA-F6C91E7F2B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64778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044C8-8525-4ABB-91BA-2E69F1B2019C}" type="datetimeFigureOut">
              <a:rPr lang="de-DE" smtClean="0"/>
              <a:t>05.08.2020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1C1D0-9BF1-4403-B9BA-F6C91E7F2B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213579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044C8-8525-4ABB-91BA-2E69F1B2019C}" type="datetimeFigureOut">
              <a:rPr lang="de-DE" smtClean="0"/>
              <a:t>05.08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1C1D0-9BF1-4403-B9BA-F6C91E7F2B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380252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044C8-8525-4ABB-91BA-2E69F1B2019C}" type="datetimeFigureOut">
              <a:rPr lang="de-DE" smtClean="0"/>
              <a:t>05.08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1C1D0-9BF1-4403-B9BA-F6C91E7F2B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380174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3044C8-8525-4ABB-91BA-2E69F1B2019C}" type="datetimeFigureOut">
              <a:rPr lang="de-DE" smtClean="0"/>
              <a:t>05.08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B1C1D0-9BF1-4403-B9BA-F6C91E7F2B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665743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/>
          <p:cNvSpPr txBox="1"/>
          <p:nvPr/>
        </p:nvSpPr>
        <p:spPr>
          <a:xfrm>
            <a:off x="244384" y="1109489"/>
            <a:ext cx="841603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Table 1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rrelation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trix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phingolipi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nzymes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ehaviour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rain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eurochemistry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ol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am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– p&lt;0.05; AC –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ramidas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NC – neutral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ramidas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ru-RU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VS </a:t>
            </a:r>
            <a:r>
              <a:rPr lang="ru-RU" sz="1200" dirty="0">
                <a:latin typeface="Arial" panose="020B0604020202020204" pitchFamily="34" charset="0"/>
                <a:cs typeface="Arial" panose="020B0604020202020204" pitchFamily="34" charset="0"/>
              </a:rPr>
              <a:t>– ventral striatum, DS – dorsal striatum, DH – dorsal hippocampus, VM – ventral mesencephalon, Hyp – hypothalamus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NOR –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vel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bject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cognition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est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EPM –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levate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plus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z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est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NSF –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velty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resse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eeding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est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NA - 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radrenalin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DA -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opamin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5-HT –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rotonin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173794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6000" y="576000"/>
            <a:ext cx="8271467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38055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8000" y="576000"/>
            <a:ext cx="6724553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183229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6</Words>
  <Application>Microsoft Office PowerPoint</Application>
  <PresentationFormat>Bildschirmpräsentation (4:3)</PresentationFormat>
  <Paragraphs>1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</vt:vector>
  </TitlesOfParts>
  <Company>Universitätsklinikum Erlang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üller, Christian</dc:creator>
  <cp:lastModifiedBy>Müller, Christian</cp:lastModifiedBy>
  <cp:revision>6</cp:revision>
  <dcterms:created xsi:type="dcterms:W3CDTF">2020-08-04T12:38:38Z</dcterms:created>
  <dcterms:modified xsi:type="dcterms:W3CDTF">2020-08-05T08:14:29Z</dcterms:modified>
</cp:coreProperties>
</file>